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F36D5-8E2C-41EC-B3EA-1F5B73DE9C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298DD-FA1C-481F-8545-164604E6B5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C0851-8930-4E24-9FF2-32685D501D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29851-81BE-43DB-B865-588CF57699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8F40B-D888-4BAE-AF3F-F868FB2679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ECF7E-BE13-4C2F-968A-CB233E3E67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160CA-2EEF-4EFF-B651-0AC877B329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04182-2BB1-4F36-A67D-34A11EFAAC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3DEDB-894C-47F3-B490-3D899A1F80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4C9AC-C4E2-41F3-AFAC-7DE435D281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CFFE7-40D3-4F70-B9F5-55D55E606B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715F2-E2A0-4A63-AD4B-223FF629C9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8CBA51-B7F1-4649-B9EF-D12B3E1B7FF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C:\Users\Zhi-Yuan.Chen\AppData\Roaming\Tencent\Users\233627037\QQ\WinTemp\RichOle\DEQS7]MJ@4ZKOQY0]B7Z[[3.jpg"/>
          <p:cNvPicPr/>
          <p:nvPr/>
        </p:nvPicPr>
        <p:blipFill>
          <a:blip r:embed="rId1"/>
          <a:stretch/>
        </p:blipFill>
        <p:spPr>
          <a:xfrm>
            <a:off x="2819520" y="4419720"/>
            <a:ext cx="3352680" cy="473040"/>
          </a:xfrm>
          <a:prstGeom prst="rect">
            <a:avLst/>
          </a:prstGeom>
          <a:ln w="0">
            <a:noFill/>
          </a:ln>
        </p:spPr>
      </p:pic>
      <p:sp>
        <p:nvSpPr>
          <p:cNvPr id="42" name="TextBox 3"/>
          <p:cNvSpPr/>
          <p:nvPr/>
        </p:nvSpPr>
        <p:spPr>
          <a:xfrm>
            <a:off x="2050560" y="4502160"/>
            <a:ext cx="76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8" descr="C:\Users\Zhi-Yuan.Chen\AppData\Roaming\Tencent\Users\233627037\QQ\WinTemp\RichOle\5GU3DP~E%8{NK(4QKL@T]D8.jpg"/>
          <p:cNvPicPr/>
          <p:nvPr/>
        </p:nvPicPr>
        <p:blipFill>
          <a:blip r:embed="rId2"/>
          <a:stretch/>
        </p:blipFill>
        <p:spPr>
          <a:xfrm>
            <a:off x="2819520" y="3886200"/>
            <a:ext cx="3352680" cy="473040"/>
          </a:xfrm>
          <a:prstGeom prst="rect">
            <a:avLst/>
          </a:prstGeom>
          <a:ln w="0">
            <a:noFill/>
          </a:ln>
        </p:spPr>
      </p:pic>
      <p:sp>
        <p:nvSpPr>
          <p:cNvPr id="44" name="TextBox 9"/>
          <p:cNvSpPr/>
          <p:nvPr/>
        </p:nvSpPr>
        <p:spPr>
          <a:xfrm>
            <a:off x="2257920" y="3968640"/>
            <a:ext cx="5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lt-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11"/>
          <p:cNvSpPr/>
          <p:nvPr/>
        </p:nvSpPr>
        <p:spPr>
          <a:xfrm rot="10800000">
            <a:off x="3108240" y="1743120"/>
            <a:ext cx="474840" cy="144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HCC9-7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12"/>
          <p:cNvSpPr/>
          <p:nvPr/>
        </p:nvSpPr>
        <p:spPr>
          <a:xfrm rot="10800000">
            <a:off x="3787560" y="2252520"/>
            <a:ext cx="474840" cy="93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ep3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13"/>
          <p:cNvSpPr/>
          <p:nvPr/>
        </p:nvSpPr>
        <p:spPr>
          <a:xfrm rot="10800000">
            <a:off x="4092480" y="2133720"/>
            <a:ext cx="474840" cy="104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RL223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14"/>
          <p:cNvSpPr/>
          <p:nvPr/>
        </p:nvSpPr>
        <p:spPr>
          <a:xfrm rot="10800000">
            <a:off x="4397400" y="2279160"/>
            <a:ext cx="474840" cy="90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UVE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15"/>
          <p:cNvSpPr/>
          <p:nvPr/>
        </p:nvSpPr>
        <p:spPr>
          <a:xfrm rot="10800000">
            <a:off x="5692680" y="2414520"/>
            <a:ext cx="474840" cy="76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BM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16"/>
          <p:cNvSpPr/>
          <p:nvPr/>
        </p:nvSpPr>
        <p:spPr>
          <a:xfrm rot="10800000">
            <a:off x="4701960" y="2284200"/>
            <a:ext cx="474840" cy="89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MVE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17"/>
          <p:cNvSpPr/>
          <p:nvPr/>
        </p:nvSpPr>
        <p:spPr>
          <a:xfrm rot="10800000">
            <a:off x="5006880" y="2115720"/>
            <a:ext cx="474840" cy="10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LMVE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8"/>
          <p:cNvSpPr/>
          <p:nvPr/>
        </p:nvSpPr>
        <p:spPr>
          <a:xfrm rot="10800000">
            <a:off x="5333760" y="2277720"/>
            <a:ext cx="474840" cy="90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UAE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9"/>
          <p:cNvSpPr/>
          <p:nvPr/>
        </p:nvSpPr>
        <p:spPr>
          <a:xfrm rot="10800000">
            <a:off x="2743200" y="1958760"/>
            <a:ext cx="474840" cy="12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QGY-77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 Box 20"/>
          <p:cNvSpPr/>
          <p:nvPr/>
        </p:nvSpPr>
        <p:spPr>
          <a:xfrm rot="10800000">
            <a:off x="3460680" y="1922400"/>
            <a:ext cx="474840" cy="127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0680" rIns="130680" tIns="65160" bIns="6516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MCC772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20"/>
          <p:cNvSpPr/>
          <p:nvPr/>
        </p:nvSpPr>
        <p:spPr>
          <a:xfrm flipH="1">
            <a:off x="2895480" y="2021040"/>
            <a:ext cx="1503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21"/>
          <p:cNvSpPr/>
          <p:nvPr/>
        </p:nvSpPr>
        <p:spPr>
          <a:xfrm flipH="1">
            <a:off x="4571640" y="2021040"/>
            <a:ext cx="1484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7"/>
          <p:cNvSpPr/>
          <p:nvPr/>
        </p:nvSpPr>
        <p:spPr>
          <a:xfrm>
            <a:off x="3084480" y="1639800"/>
            <a:ext cx="143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CC lin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97"/>
          <p:cNvSpPr/>
          <p:nvPr/>
        </p:nvSpPr>
        <p:spPr>
          <a:xfrm>
            <a:off x="4724280" y="1649520"/>
            <a:ext cx="1235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C lin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24" descr="C:\Users\Zhi-Yuan.Chen\AppData\Roaming\Tencent\Users\233627037\QQ\WinTemp\RichOle\DISXOKTCSS{PBNAEBV)CHVY.jpg"/>
          <p:cNvPicPr/>
          <p:nvPr/>
        </p:nvPicPr>
        <p:blipFill>
          <a:blip r:embed="rId3"/>
          <a:stretch/>
        </p:blipFill>
        <p:spPr>
          <a:xfrm>
            <a:off x="2825640" y="3352680"/>
            <a:ext cx="3346560" cy="473040"/>
          </a:xfrm>
          <a:prstGeom prst="rect">
            <a:avLst/>
          </a:prstGeom>
          <a:ln w="0">
            <a:noFill/>
          </a:ln>
        </p:spPr>
      </p:pic>
      <p:sp>
        <p:nvSpPr>
          <p:cNvPr id="60" name="TextBox 9"/>
          <p:cNvSpPr/>
          <p:nvPr/>
        </p:nvSpPr>
        <p:spPr>
          <a:xfrm>
            <a:off x="2275560" y="3435480"/>
            <a:ext cx="5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-ki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2"/>
          <p:cNvSpPr/>
          <p:nvPr/>
        </p:nvSpPr>
        <p:spPr>
          <a:xfrm>
            <a:off x="2863440" y="685800"/>
            <a:ext cx="2975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Figure not shown 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Chen, Zhi-Yuan</dc:creator>
  <dc:description/>
  <dc:language>en-US</dc:language>
  <cp:lastModifiedBy>Zhi-Yuan Chen</cp:lastModifiedBy>
  <dcterms:modified xsi:type="dcterms:W3CDTF">2012-10-31T15:15:06Z</dcterms:modified>
  <cp:revision>10</cp:revision>
  <dc:subject/>
  <dc:title>PowerPoint Presentation</dc:title>
</cp:coreProperties>
</file>